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4319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706933"/>
            <a:ext cx="9144000" cy="150385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2268784"/>
            <a:ext cx="9144000" cy="1042900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8789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95944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229978"/>
            <a:ext cx="2628900" cy="366065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229978"/>
            <a:ext cx="7734300" cy="3660651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32487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85090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076898"/>
            <a:ext cx="10515600" cy="1796828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2890725"/>
            <a:ext cx="10515600" cy="944910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14631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149890"/>
            <a:ext cx="5181600" cy="274073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149890"/>
            <a:ext cx="5181600" cy="274073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50264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229978"/>
            <a:ext cx="10515600" cy="8349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058899"/>
            <a:ext cx="5157787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1577849"/>
            <a:ext cx="5157787" cy="23207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058899"/>
            <a:ext cx="5183188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1577849"/>
            <a:ext cx="5183188" cy="23207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0355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793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6607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287972"/>
            <a:ext cx="3932237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621941"/>
            <a:ext cx="6172200" cy="3069707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295877"/>
            <a:ext cx="3932237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6456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287972"/>
            <a:ext cx="3932237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621941"/>
            <a:ext cx="6172200" cy="3069707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295877"/>
            <a:ext cx="3932237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07941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229978"/>
            <a:ext cx="10515600" cy="834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149890"/>
            <a:ext cx="10515600" cy="27407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4003618"/>
            <a:ext cx="2743200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B6B3D-DF39-4F70-955F-C950DBF5F0FE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4003618"/>
            <a:ext cx="4114800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4003618"/>
            <a:ext cx="2743200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B76BA-3677-4319-A407-0A36B4A08B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45104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75981" rtl="1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r" defTabSz="575981" rtl="1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r" defTabSz="575981" rtl="1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r" defTabSz="575981" rtl="1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278819" y="17536"/>
            <a:ext cx="11634363" cy="4284517"/>
            <a:chOff x="63844" y="1116158"/>
            <a:chExt cx="11634363" cy="4284517"/>
          </a:xfrm>
        </p:grpSpPr>
        <p:sp>
          <p:nvSpPr>
            <p:cNvPr id="12" name="Rectangle 11"/>
            <p:cNvSpPr/>
            <p:nvPr/>
          </p:nvSpPr>
          <p:spPr>
            <a:xfrm>
              <a:off x="63844" y="4754344"/>
              <a:ext cx="1163436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</a:rPr>
                <a:t>S</a:t>
              </a:r>
              <a:r>
                <a:rPr lang="en-US" b="1" dirty="0" smtClean="0">
                  <a:latin typeface="Times New Roman" panose="02020603050405020304" pitchFamily="18" charset="0"/>
                </a:rPr>
                <a:t>6: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hannon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nd Phylogenetic Diversity indices of the filtered and unfiltered wastewater solutions used for MFCs inoculation.  </a:t>
              </a:r>
              <a:endParaRPr lang="en-US" dirty="0"/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3781651" y="1116158"/>
              <a:ext cx="4198749" cy="3444463"/>
              <a:chOff x="7646044" y="2385795"/>
              <a:chExt cx="3333686" cy="2399936"/>
            </a:xfrm>
          </p:grpSpPr>
          <p:graphicFrame>
            <p:nvGraphicFramePr>
              <p:cNvPr id="14" name="Object 1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06207066"/>
                  </p:ext>
                </p:extLst>
              </p:nvPr>
            </p:nvGraphicFramePr>
            <p:xfrm>
              <a:off x="7646044" y="2385795"/>
              <a:ext cx="3333686" cy="239993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7" name="Prism 5" r:id="rId3" imgW="3995640" imgH="2876040" progId="Prism5.Document">
                      <p:embed/>
                    </p:oleObj>
                  </mc:Choice>
                  <mc:Fallback>
                    <p:oleObj name="Prism 5" r:id="rId3" imgW="3995640" imgH="2876040" progId="Prism5.Document">
                      <p:embed/>
                      <p:pic>
                        <p:nvPicPr>
                          <p:cNvPr id="8" name="Object 7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7646044" y="2385795"/>
                            <a:ext cx="3333686" cy="239993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תיבת טקסט 5">
                <a:extLst>
                  <a:ext uri="{FF2B5EF4-FFF2-40B4-BE49-F238E27FC236}">
                    <a16:creationId xmlns:a16="http://schemas.microsoft.com/office/drawing/2014/main" id="{9A1C5D5A-D8F0-401D-B775-AF10DE53406C}"/>
                  </a:ext>
                </a:extLst>
              </p:cNvPr>
              <p:cNvSpPr txBox="1"/>
              <p:nvPr/>
            </p:nvSpPr>
            <p:spPr>
              <a:xfrm>
                <a:off x="10216342" y="2882533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he-IL" sz="1400" dirty="0"/>
                  <a:t>*</a:t>
                </a:r>
              </a:p>
            </p:txBody>
          </p:sp>
          <p:sp>
            <p:nvSpPr>
              <p:cNvPr id="16" name="תיבת טקסט 5">
                <a:extLst>
                  <a:ext uri="{FF2B5EF4-FFF2-40B4-BE49-F238E27FC236}">
                    <a16:creationId xmlns:a16="http://schemas.microsoft.com/office/drawing/2014/main" id="{9A1C5D5A-D8F0-401D-B775-AF10DE53406C}"/>
                  </a:ext>
                </a:extLst>
              </p:cNvPr>
              <p:cNvSpPr txBox="1"/>
              <p:nvPr/>
            </p:nvSpPr>
            <p:spPr>
              <a:xfrm>
                <a:off x="8872451" y="2893121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he-IL" sz="1400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50811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2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10:20:44Z</dcterms:created>
  <dcterms:modified xsi:type="dcterms:W3CDTF">2020-02-16T10:23:49Z</dcterms:modified>
</cp:coreProperties>
</file>